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9" autoAdjust="0"/>
    <p:restoredTop sz="94660"/>
  </p:normalViewPr>
  <p:slideViewPr>
    <p:cSldViewPr snapToGrid="0">
      <p:cViewPr varScale="1">
        <p:scale>
          <a:sx n="67" d="100"/>
          <a:sy n="67" d="100"/>
        </p:scale>
        <p:origin x="60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chu\Documents\CIHI%20HCV%20data\HCV_hospitalizations_updated%20GRAPH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Yearly rate of HCV-specific hospitalizations per 1,000,000 of Canadian population, by age group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1"/>
          <c:order val="0"/>
          <c:tx>
            <c:strRef>
              <c:f>Age!$N$1</c:f>
              <c:strCache>
                <c:ptCount val="1"/>
                <c:pt idx="0">
                  <c:v>Under 30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numRef>
              <c:f>Age!$A$2:$A$15</c:f>
              <c:numCache>
                <c:formatCode>General</c:formatCode>
                <c:ptCount val="14"/>
                <c:pt idx="0">
                  <c:v>2006</c:v>
                </c:pt>
                <c:pt idx="1">
                  <c:v>2007</c:v>
                </c:pt>
                <c:pt idx="2">
                  <c:v>2008</c:v>
                </c:pt>
                <c:pt idx="3">
                  <c:v>2009</c:v>
                </c:pt>
                <c:pt idx="4">
                  <c:v>2010</c:v>
                </c:pt>
                <c:pt idx="5">
                  <c:v>2011</c:v>
                </c:pt>
                <c:pt idx="6">
                  <c:v>2012</c:v>
                </c:pt>
                <c:pt idx="7">
                  <c:v>2013</c:v>
                </c:pt>
                <c:pt idx="8">
                  <c:v>2014</c:v>
                </c:pt>
                <c:pt idx="9">
                  <c:v>2015</c:v>
                </c:pt>
                <c:pt idx="10">
                  <c:v>2016</c:v>
                </c:pt>
                <c:pt idx="11">
                  <c:v>2017</c:v>
                </c:pt>
                <c:pt idx="12">
                  <c:v>2018</c:v>
                </c:pt>
                <c:pt idx="13">
                  <c:v>2019</c:v>
                </c:pt>
              </c:numCache>
            </c:numRef>
          </c:cat>
          <c:val>
            <c:numRef>
              <c:f>Age!$N$2:$N$15</c:f>
              <c:numCache>
                <c:formatCode>General</c:formatCode>
                <c:ptCount val="14"/>
                <c:pt idx="0">
                  <c:v>31.636031764853037</c:v>
                </c:pt>
                <c:pt idx="1">
                  <c:v>29.904303796606648</c:v>
                </c:pt>
                <c:pt idx="2">
                  <c:v>31.19769398254525</c:v>
                </c:pt>
                <c:pt idx="3">
                  <c:v>26.674433492707063</c:v>
                </c:pt>
                <c:pt idx="4">
                  <c:v>27.090761381067892</c:v>
                </c:pt>
                <c:pt idx="5">
                  <c:v>25.663904552522411</c:v>
                </c:pt>
                <c:pt idx="6">
                  <c:v>26.520320938632533</c:v>
                </c:pt>
                <c:pt idx="7">
                  <c:v>26.995165734136297</c:v>
                </c:pt>
                <c:pt idx="8">
                  <c:v>27.070783094012661</c:v>
                </c:pt>
                <c:pt idx="9">
                  <c:v>30.286405557468889</c:v>
                </c:pt>
                <c:pt idx="10">
                  <c:v>35.616752495750198</c:v>
                </c:pt>
                <c:pt idx="11">
                  <c:v>36.306612672772836</c:v>
                </c:pt>
                <c:pt idx="12">
                  <c:v>58.391357834469368</c:v>
                </c:pt>
                <c:pt idx="13">
                  <c:v>42.34812167553065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780-4112-B2A2-C54DF4EB6C23}"/>
            </c:ext>
          </c:extLst>
        </c:ser>
        <c:ser>
          <c:idx val="2"/>
          <c:order val="1"/>
          <c:tx>
            <c:strRef>
              <c:f>Age!$O$1</c:f>
              <c:strCache>
                <c:ptCount val="1"/>
                <c:pt idx="0">
                  <c:v>30 to 49</c:v>
                </c:pt>
              </c:strCache>
            </c:strRef>
          </c:tx>
          <c:spPr>
            <a:ln w="28575" cap="rnd">
              <a:solidFill>
                <a:srgbClr val="7030A0"/>
              </a:solidFill>
              <a:round/>
            </a:ln>
            <a:effectLst/>
          </c:spPr>
          <c:marker>
            <c:symbol val="none"/>
          </c:marker>
          <c:cat>
            <c:numRef>
              <c:f>Age!$A$2:$A$15</c:f>
              <c:numCache>
                <c:formatCode>General</c:formatCode>
                <c:ptCount val="14"/>
                <c:pt idx="0">
                  <c:v>2006</c:v>
                </c:pt>
                <c:pt idx="1">
                  <c:v>2007</c:v>
                </c:pt>
                <c:pt idx="2">
                  <c:v>2008</c:v>
                </c:pt>
                <c:pt idx="3">
                  <c:v>2009</c:v>
                </c:pt>
                <c:pt idx="4">
                  <c:v>2010</c:v>
                </c:pt>
                <c:pt idx="5">
                  <c:v>2011</c:v>
                </c:pt>
                <c:pt idx="6">
                  <c:v>2012</c:v>
                </c:pt>
                <c:pt idx="7">
                  <c:v>2013</c:v>
                </c:pt>
                <c:pt idx="8">
                  <c:v>2014</c:v>
                </c:pt>
                <c:pt idx="9">
                  <c:v>2015</c:v>
                </c:pt>
                <c:pt idx="10">
                  <c:v>2016</c:v>
                </c:pt>
                <c:pt idx="11">
                  <c:v>2017</c:v>
                </c:pt>
                <c:pt idx="12">
                  <c:v>2018</c:v>
                </c:pt>
                <c:pt idx="13">
                  <c:v>2019</c:v>
                </c:pt>
              </c:numCache>
            </c:numRef>
          </c:cat>
          <c:val>
            <c:numRef>
              <c:f>Age!$O$2:$O$15</c:f>
              <c:numCache>
                <c:formatCode>General</c:formatCode>
                <c:ptCount val="14"/>
                <c:pt idx="0">
                  <c:v>351.33955287994206</c:v>
                </c:pt>
                <c:pt idx="1">
                  <c:v>325.73971669382519</c:v>
                </c:pt>
                <c:pt idx="2">
                  <c:v>320.46192180525253</c:v>
                </c:pt>
                <c:pt idx="3">
                  <c:v>319.92189408479749</c:v>
                </c:pt>
                <c:pt idx="4">
                  <c:v>308.85938158576471</c:v>
                </c:pt>
                <c:pt idx="5">
                  <c:v>295.01953847526727</c:v>
                </c:pt>
                <c:pt idx="6">
                  <c:v>282.18461410300347</c:v>
                </c:pt>
                <c:pt idx="7">
                  <c:v>269.27979275681776</c:v>
                </c:pt>
                <c:pt idx="8">
                  <c:v>252.29915104129802</c:v>
                </c:pt>
                <c:pt idx="9">
                  <c:v>239.10752027428185</c:v>
                </c:pt>
                <c:pt idx="10">
                  <c:v>231.80359845620043</c:v>
                </c:pt>
                <c:pt idx="11">
                  <c:v>240.89497564107367</c:v>
                </c:pt>
                <c:pt idx="12">
                  <c:v>302.03513668661981</c:v>
                </c:pt>
                <c:pt idx="13">
                  <c:v>246.5346492107743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780-4112-B2A2-C54DF4EB6C23}"/>
            </c:ext>
          </c:extLst>
        </c:ser>
        <c:ser>
          <c:idx val="3"/>
          <c:order val="2"/>
          <c:tx>
            <c:strRef>
              <c:f>Age!$P$1</c:f>
              <c:strCache>
                <c:ptCount val="1"/>
                <c:pt idx="0">
                  <c:v>50 to 64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cat>
            <c:numRef>
              <c:f>Age!$A$2:$A$15</c:f>
              <c:numCache>
                <c:formatCode>General</c:formatCode>
                <c:ptCount val="14"/>
                <c:pt idx="0">
                  <c:v>2006</c:v>
                </c:pt>
                <c:pt idx="1">
                  <c:v>2007</c:v>
                </c:pt>
                <c:pt idx="2">
                  <c:v>2008</c:v>
                </c:pt>
                <c:pt idx="3">
                  <c:v>2009</c:v>
                </c:pt>
                <c:pt idx="4">
                  <c:v>2010</c:v>
                </c:pt>
                <c:pt idx="5">
                  <c:v>2011</c:v>
                </c:pt>
                <c:pt idx="6">
                  <c:v>2012</c:v>
                </c:pt>
                <c:pt idx="7">
                  <c:v>2013</c:v>
                </c:pt>
                <c:pt idx="8">
                  <c:v>2014</c:v>
                </c:pt>
                <c:pt idx="9">
                  <c:v>2015</c:v>
                </c:pt>
                <c:pt idx="10">
                  <c:v>2016</c:v>
                </c:pt>
                <c:pt idx="11">
                  <c:v>2017</c:v>
                </c:pt>
                <c:pt idx="12">
                  <c:v>2018</c:v>
                </c:pt>
                <c:pt idx="13">
                  <c:v>2019</c:v>
                </c:pt>
              </c:numCache>
            </c:numRef>
          </c:cat>
          <c:val>
            <c:numRef>
              <c:f>Age!$P$2:$P$15</c:f>
              <c:numCache>
                <c:formatCode>General</c:formatCode>
                <c:ptCount val="14"/>
                <c:pt idx="0">
                  <c:v>506.09287084062129</c:v>
                </c:pt>
                <c:pt idx="1">
                  <c:v>534.83328457473681</c:v>
                </c:pt>
                <c:pt idx="2">
                  <c:v>551.27564537229671</c:v>
                </c:pt>
                <c:pt idx="3">
                  <c:v>619.83829213929084</c:v>
                </c:pt>
                <c:pt idx="4">
                  <c:v>657.95412345688317</c:v>
                </c:pt>
                <c:pt idx="5">
                  <c:v>670.71889139386474</c:v>
                </c:pt>
                <c:pt idx="6">
                  <c:v>672.5106797905629</c:v>
                </c:pt>
                <c:pt idx="7">
                  <c:v>723.33994972123367</c:v>
                </c:pt>
                <c:pt idx="8">
                  <c:v>690.27383697363962</c:v>
                </c:pt>
                <c:pt idx="9">
                  <c:v>669.13319833759726</c:v>
                </c:pt>
                <c:pt idx="10">
                  <c:v>591.42493479676216</c:v>
                </c:pt>
                <c:pt idx="11">
                  <c:v>524.15392111522203</c:v>
                </c:pt>
                <c:pt idx="12">
                  <c:v>551.14695226037213</c:v>
                </c:pt>
                <c:pt idx="13">
                  <c:v>471.2522002278790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780-4112-B2A2-C54DF4EB6C23}"/>
            </c:ext>
          </c:extLst>
        </c:ser>
        <c:ser>
          <c:idx val="4"/>
          <c:order val="3"/>
          <c:tx>
            <c:strRef>
              <c:f>Age!$Q$1</c:f>
              <c:strCache>
                <c:ptCount val="1"/>
                <c:pt idx="0">
                  <c:v>65+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Age!$A$2:$A$15</c:f>
              <c:numCache>
                <c:formatCode>General</c:formatCode>
                <c:ptCount val="14"/>
                <c:pt idx="0">
                  <c:v>2006</c:v>
                </c:pt>
                <c:pt idx="1">
                  <c:v>2007</c:v>
                </c:pt>
                <c:pt idx="2">
                  <c:v>2008</c:v>
                </c:pt>
                <c:pt idx="3">
                  <c:v>2009</c:v>
                </c:pt>
                <c:pt idx="4">
                  <c:v>2010</c:v>
                </c:pt>
                <c:pt idx="5">
                  <c:v>2011</c:v>
                </c:pt>
                <c:pt idx="6">
                  <c:v>2012</c:v>
                </c:pt>
                <c:pt idx="7">
                  <c:v>2013</c:v>
                </c:pt>
                <c:pt idx="8">
                  <c:v>2014</c:v>
                </c:pt>
                <c:pt idx="9">
                  <c:v>2015</c:v>
                </c:pt>
                <c:pt idx="10">
                  <c:v>2016</c:v>
                </c:pt>
                <c:pt idx="11">
                  <c:v>2017</c:v>
                </c:pt>
                <c:pt idx="12">
                  <c:v>2018</c:v>
                </c:pt>
                <c:pt idx="13">
                  <c:v>2019</c:v>
                </c:pt>
              </c:numCache>
            </c:numRef>
          </c:cat>
          <c:val>
            <c:numRef>
              <c:f>Age!$Q$2:$Q$15</c:f>
              <c:numCache>
                <c:formatCode>General</c:formatCode>
                <c:ptCount val="14"/>
                <c:pt idx="0">
                  <c:v>257.47260996187458</c:v>
                </c:pt>
                <c:pt idx="1">
                  <c:v>239.0656851629322</c:v>
                </c:pt>
                <c:pt idx="2">
                  <c:v>242.67162521283313</c:v>
                </c:pt>
                <c:pt idx="3">
                  <c:v>256.56813350966149</c:v>
                </c:pt>
                <c:pt idx="4">
                  <c:v>265.81931988139087</c:v>
                </c:pt>
                <c:pt idx="5">
                  <c:v>271.83372736106361</c:v>
                </c:pt>
                <c:pt idx="6">
                  <c:v>245.39582152022422</c:v>
                </c:pt>
                <c:pt idx="7">
                  <c:v>281.71208464514086</c:v>
                </c:pt>
                <c:pt idx="8">
                  <c:v>263.24687504849044</c:v>
                </c:pt>
                <c:pt idx="9">
                  <c:v>286.95071525349266</c:v>
                </c:pt>
                <c:pt idx="10">
                  <c:v>274.27947592353144</c:v>
                </c:pt>
                <c:pt idx="11">
                  <c:v>240.91232421387275</c:v>
                </c:pt>
                <c:pt idx="12">
                  <c:v>263.70644123437273</c:v>
                </c:pt>
                <c:pt idx="13">
                  <c:v>225.3026889353197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780-4112-B2A2-C54DF4EB6C2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83954831"/>
        <c:axId val="283956495"/>
      </c:lineChart>
      <c:catAx>
        <c:axId val="28395483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Year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83956495"/>
        <c:crosses val="autoZero"/>
        <c:auto val="1"/>
        <c:lblAlgn val="ctr"/>
        <c:lblOffset val="100"/>
        <c:noMultiLvlLbl val="0"/>
      </c:catAx>
      <c:valAx>
        <c:axId val="28395649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ate per 1,000,000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8395483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6C58CF-3FFD-48A4-912A-74680D42628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0ADDAC4-76DD-4206-B11D-5C1A8CB8ADB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1F9305-9CA6-4CBD-A131-79149E698B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20058-503A-4FFD-8024-4AB451166632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335A87-6502-4A36-BC00-486384DEEC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26212F-F7D6-425F-900A-9E17B9A381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FE109-585C-4800-B73D-089FE07589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24927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8FB4DD-1918-4FF6-900B-450C401E87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6624CC7-E370-4BB4-B5E3-89E924859A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D846BF-5C4A-446E-B812-545204A885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20058-503A-4FFD-8024-4AB451166632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F2F759-A4A5-4495-AE32-302E9EDB1D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39FECB-98EB-486B-8BDF-614B34CE6F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FE109-585C-4800-B73D-089FE07589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07898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4B5028A-D243-4E8C-98F7-2D85030F153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253EDCA-DBA6-482B-A8E1-95E2005641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3CB44C-828C-49A1-9567-25DD1D95A1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20058-503A-4FFD-8024-4AB451166632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416103-C02F-41A6-A01E-A7AFA493B4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0BE711-4D64-4EF9-8319-444A7C8A20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FE109-585C-4800-B73D-089FE07589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71308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B3C1FB-B46E-4209-9C15-8F69D0F433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695482-D887-40F5-B9C1-CB32F241C7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F3EFC8-8DB1-40CC-B515-4DF6CEDDB8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20058-503A-4FFD-8024-4AB451166632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DC0AE5-E269-4D91-B23D-CD10902B88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ADF043-E311-413B-B628-D010B379E4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FE109-585C-4800-B73D-089FE07589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955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1A716B-456B-4692-B187-6DE088C7F3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4E2FD4-AF1A-44CF-A714-26A4E90937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6AB071-50A8-414E-B923-C659454BEB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20058-503A-4FFD-8024-4AB451166632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F0F823-8E7C-436C-A953-5C3445D422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5DCB3E-481F-43EF-8EF5-C9A8708347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FE109-585C-4800-B73D-089FE07589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1922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5C67BE-4DD3-4D9D-8D6D-B6D178D455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0AA8C5-19BD-40E4-947C-D46FAE3482A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0E10E4-D75B-4983-916B-D0979EB084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F1A422-BEF1-4D47-B273-2BAECBC248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20058-503A-4FFD-8024-4AB451166632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CB1E2FC-1C24-4B33-94B3-6DBC354D74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78FA3E-DA62-49CA-9FD9-1693143BB4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FE109-585C-4800-B73D-089FE07589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396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BACA69-657F-47D4-A68C-DB87D2918E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C31CDF-0239-452C-B444-BF2970020B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E4E78C-4A08-484D-B90B-27FAA00B49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04B4FEA-66F5-4004-BD93-FFE0CD99C96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0FAC279-DCD0-449D-9387-3B155C35500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48AB547-303D-471D-9E1B-5C16FC50B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20058-503A-4FFD-8024-4AB451166632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4DD8860-34F4-4BC5-ACB8-70374FECF6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5B14979-E4E0-48C7-AC92-B7E580C1BC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FE109-585C-4800-B73D-089FE07589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49851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6CCB6D-1DE9-4660-8B8C-CA56B2121A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B138822-A07A-462E-A3D9-4094A9E274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20058-503A-4FFD-8024-4AB451166632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A083347-2DDF-4F6C-935E-9D2CFAAF6C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6DE296B-8EDE-4CAC-B886-A47D09EBC7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FE109-585C-4800-B73D-089FE07589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4834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602FE51-F685-470A-B947-46BBE0A88D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20058-503A-4FFD-8024-4AB451166632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795C920-6B47-4818-8FCE-CB1D407D24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F3BA06B-C616-4C21-8146-C15B0282E2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FE109-585C-4800-B73D-089FE07589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4213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C6A423-2A6D-4A66-83DD-5FAA6210D2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F89023-8175-4EF6-93C1-6F447C7AE5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E157CA4-3854-4937-B346-58CF5B3805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3929EC-94D7-4155-95AD-4A519E455B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20058-503A-4FFD-8024-4AB451166632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BF8A7F-EE68-492F-846A-29A320169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C95679-E2C5-4A2C-8AC0-396140FFD6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FE109-585C-4800-B73D-089FE07589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36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02AD7E-A5D6-4D0F-A97A-E94342B253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AE0EA07-1237-46F3-9F14-AA94246ADE1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D8DA3D6-4EE9-4C9B-A1B4-AE9965A1EB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021AB1C-25EC-412F-9FC2-B7453AFB30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F20058-503A-4FFD-8024-4AB451166632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A06567-BD8E-4D90-8201-A5ABE229A2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0E6892-DBD2-4B45-B614-CF2D71DE31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FE109-585C-4800-B73D-089FE07589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8737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6C18CA3-6D59-4EB4-AF79-C2B3A5623B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5ADB42-92ED-4EFC-8B13-9CF2A5A525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802F21-E662-4DCA-A72B-4FDB66448EE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F20058-503A-4FFD-8024-4AB451166632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F5F141-4397-480E-99ED-B44E161DEC7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A3E31C-ED66-4A7F-A6BF-219F8A95552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3FE109-585C-4800-B73D-089FE07589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55501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E59C2E86-6B21-4125-A630-FD22BAFC70E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57775072"/>
              </p:ext>
            </p:extLst>
          </p:nvPr>
        </p:nvGraphicFramePr>
        <p:xfrm>
          <a:off x="1536357" y="1124464"/>
          <a:ext cx="8435546" cy="45390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C3DFA574-529A-442B-BC5D-8BB701F0DEE8}"/>
              </a:ext>
            </a:extLst>
          </p:cNvPr>
          <p:cNvCxnSpPr>
            <a:cxnSpLocks/>
          </p:cNvCxnSpPr>
          <p:nvPr/>
        </p:nvCxnSpPr>
        <p:spPr>
          <a:xfrm>
            <a:off x="6794158" y="1738184"/>
            <a:ext cx="28833" cy="3076832"/>
          </a:xfrm>
          <a:prstGeom prst="line">
            <a:avLst/>
          </a:prstGeom>
          <a:ln w="285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C3DFA574-529A-442B-BC5D-8BB701F0DEE8}"/>
              </a:ext>
            </a:extLst>
          </p:cNvPr>
          <p:cNvCxnSpPr>
            <a:cxnSpLocks/>
          </p:cNvCxnSpPr>
          <p:nvPr/>
        </p:nvCxnSpPr>
        <p:spPr>
          <a:xfrm>
            <a:off x="8429368" y="1738184"/>
            <a:ext cx="28833" cy="3076832"/>
          </a:xfrm>
          <a:prstGeom prst="line">
            <a:avLst/>
          </a:prstGeom>
          <a:ln w="285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BEEB7823-3BFC-4978-C886-33CAC4C61DBB}"/>
              </a:ext>
            </a:extLst>
          </p:cNvPr>
          <p:cNvSpPr txBox="1"/>
          <p:nvPr/>
        </p:nvSpPr>
        <p:spPr>
          <a:xfrm>
            <a:off x="354227" y="350108"/>
            <a:ext cx="19894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1 Figure</a:t>
            </a:r>
          </a:p>
        </p:txBody>
      </p:sp>
    </p:spTree>
    <p:extLst>
      <p:ext uri="{BB962C8B-B14F-4D97-AF65-F5344CB8AC3E}">
        <p14:creationId xmlns:p14="http://schemas.microsoft.com/office/powerpoint/2010/main" val="31174083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20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u, Cherry</dc:creator>
  <cp:lastModifiedBy>Chu, Cherry</cp:lastModifiedBy>
  <cp:revision>13</cp:revision>
  <dcterms:created xsi:type="dcterms:W3CDTF">2023-02-07T19:35:35Z</dcterms:created>
  <dcterms:modified xsi:type="dcterms:W3CDTF">2023-07-26T15:48:44Z</dcterms:modified>
</cp:coreProperties>
</file>